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182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226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710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763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88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98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49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88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49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0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52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403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3677D-7A8B-564A-AF66-2130C00F5001}" type="datetimeFigureOut">
              <a:rPr lang="en-US" smtClean="0"/>
              <a:t>12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D4C56C-6B87-A04C-A505-F8CDDF4AFD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429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649111" y="1366838"/>
            <a:ext cx="7662333" cy="4277606"/>
            <a:chOff x="1036638" y="2643188"/>
            <a:chExt cx="6535737" cy="3438525"/>
          </a:xfrm>
        </p:grpSpPr>
        <p:grpSp>
          <p:nvGrpSpPr>
            <p:cNvPr id="4" name="Group 3"/>
            <p:cNvGrpSpPr/>
            <p:nvPr/>
          </p:nvGrpSpPr>
          <p:grpSpPr>
            <a:xfrm>
              <a:off x="1036638" y="2643188"/>
              <a:ext cx="6535737" cy="3438525"/>
              <a:chOff x="1036638" y="2643188"/>
              <a:chExt cx="6535737" cy="3438525"/>
            </a:xfrm>
          </p:grpSpPr>
          <p:sp>
            <p:nvSpPr>
              <p:cNvPr id="5" name="Freeform 2"/>
              <p:cNvSpPr>
                <a:spLocks/>
              </p:cNvSpPr>
              <p:nvPr/>
            </p:nvSpPr>
            <p:spPr bwMode="auto">
              <a:xfrm>
                <a:off x="4537075" y="3268663"/>
                <a:ext cx="2000250" cy="606425"/>
              </a:xfrm>
              <a:custGeom>
                <a:avLst/>
                <a:gdLst>
                  <a:gd name="T0" fmla="+- 0 18221 10444"/>
                  <a:gd name="T1" fmla="*/ T0 w 9111"/>
                  <a:gd name="T2" fmla="+- 0 11778 10444"/>
                  <a:gd name="T3" fmla="*/ 11778 h 9111"/>
                  <a:gd name="T4" fmla="+- 0 18221 10444"/>
                  <a:gd name="T5" fmla="*/ T4 w 9111"/>
                  <a:gd name="T6" fmla="+- 0 18221 10444"/>
                  <a:gd name="T7" fmla="*/ 18221 h 9111"/>
                  <a:gd name="T8" fmla="+- 0 11778 10444"/>
                  <a:gd name="T9" fmla="*/ T8 w 9111"/>
                  <a:gd name="T10" fmla="+- 0 18221 10444"/>
                  <a:gd name="T11" fmla="*/ 18221 h 9111"/>
                  <a:gd name="T12" fmla="+- 0 11778 10444"/>
                  <a:gd name="T13" fmla="*/ T12 w 9111"/>
                  <a:gd name="T14" fmla="+- 0 11778 10444"/>
                  <a:gd name="T15" fmla="*/ 11778 h 9111"/>
                  <a:gd name="T16" fmla="+- 0 18221 10444"/>
                  <a:gd name="T17" fmla="*/ T16 w 9111"/>
                  <a:gd name="T18" fmla="+- 0 11778 10444"/>
                  <a:gd name="T19" fmla="*/ 11778 h 9111"/>
                  <a:gd name="T20" fmla="+- 0 18221 10444"/>
                  <a:gd name="T21" fmla="*/ T20 w 9111"/>
                  <a:gd name="T22" fmla="+- 0 11778 10444"/>
                  <a:gd name="T23" fmla="*/ 11778 h 9111"/>
                </a:gdLst>
                <a:ahLst/>
                <a:cxnLst>
                  <a:cxn ang="0">
                    <a:pos x="T1" y="T3"/>
                  </a:cxn>
                  <a:cxn ang="0">
                    <a:pos x="T5" y="T7"/>
                  </a:cxn>
                  <a:cxn ang="0">
                    <a:pos x="T9" y="T11"/>
                  </a:cxn>
                  <a:cxn ang="0">
                    <a:pos x="T13" y="T15"/>
                  </a:cxn>
                  <a:cxn ang="0">
                    <a:pos x="T17" y="T19"/>
                  </a:cxn>
                  <a:cxn ang="0">
                    <a:pos x="T21" y="T23"/>
                  </a:cxn>
                </a:cxnLst>
                <a:rect l="0" t="0" r="r" b="b"/>
                <a:pathLst>
                  <a:path w="9111" h="9111">
                    <a:moveTo>
                      <a:pt x="7777" y="1334"/>
                    </a:moveTo>
                    <a:cubicBezTo>
                      <a:pt x="9556" y="3113"/>
                      <a:pt x="9556" y="5998"/>
                      <a:pt x="7777" y="7777"/>
                    </a:cubicBezTo>
                    <a:cubicBezTo>
                      <a:pt x="5998" y="9556"/>
                      <a:pt x="3113" y="9556"/>
                      <a:pt x="1334" y="7777"/>
                    </a:cubicBezTo>
                    <a:cubicBezTo>
                      <a:pt x="-445" y="5998"/>
                      <a:pt x="-445" y="3113"/>
                      <a:pt x="1334" y="1334"/>
                    </a:cubicBezTo>
                    <a:cubicBezTo>
                      <a:pt x="3113" y="-445"/>
                      <a:pt x="5998" y="-445"/>
                      <a:pt x="7777" y="1334"/>
                    </a:cubicBezTo>
                    <a:close/>
                    <a:moveTo>
                      <a:pt x="7777" y="1334"/>
                    </a:moveTo>
                  </a:path>
                </a:pathLst>
              </a:custGeom>
              <a:gradFill rotWithShape="0">
                <a:gsLst>
                  <a:gs pos="0">
                    <a:srgbClr val="CCFF66">
                      <a:alpha val="34999"/>
                    </a:srgbClr>
                  </a:gs>
                  <a:gs pos="100000">
                    <a:srgbClr val="FFFFFF"/>
                  </a:gs>
                </a:gsLst>
                <a:lin ang="16200000" scaled="1"/>
              </a:gradFill>
              <a:ln w="25400">
                <a:solidFill>
                  <a:srgbClr val="000000"/>
                </a:solidFill>
                <a:round/>
                <a:headEnd/>
                <a:tailEnd/>
              </a:ln>
              <a:effectLst>
                <a:outerShdw blurRad="63500" dist="76199" dir="2700000" algn="ctr" rotWithShape="0">
                  <a:schemeClr val="bg2">
                    <a:alpha val="75000"/>
                  </a:schemeClr>
                </a:outerShdw>
              </a:effec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" name="Freeform 3"/>
              <p:cNvSpPr>
                <a:spLocks/>
              </p:cNvSpPr>
              <p:nvPr/>
            </p:nvSpPr>
            <p:spPr bwMode="auto">
              <a:xfrm>
                <a:off x="5037138" y="3116263"/>
                <a:ext cx="990600" cy="625475"/>
              </a:xfrm>
              <a:custGeom>
                <a:avLst/>
                <a:gdLst>
                  <a:gd name="T0" fmla="+- 0 18221 10444"/>
                  <a:gd name="T1" fmla="*/ T0 w 9111"/>
                  <a:gd name="T2" fmla="+- 0 11778 10444"/>
                  <a:gd name="T3" fmla="*/ 11778 h 9111"/>
                  <a:gd name="T4" fmla="+- 0 18221 10444"/>
                  <a:gd name="T5" fmla="*/ T4 w 9111"/>
                  <a:gd name="T6" fmla="+- 0 18221 10444"/>
                  <a:gd name="T7" fmla="*/ 18221 h 9111"/>
                  <a:gd name="T8" fmla="+- 0 11778 10444"/>
                  <a:gd name="T9" fmla="*/ T8 w 9111"/>
                  <a:gd name="T10" fmla="+- 0 18221 10444"/>
                  <a:gd name="T11" fmla="*/ 18221 h 9111"/>
                  <a:gd name="T12" fmla="+- 0 11778 10444"/>
                  <a:gd name="T13" fmla="*/ T12 w 9111"/>
                  <a:gd name="T14" fmla="+- 0 11778 10444"/>
                  <a:gd name="T15" fmla="*/ 11778 h 9111"/>
                  <a:gd name="T16" fmla="+- 0 18221 10444"/>
                  <a:gd name="T17" fmla="*/ T16 w 9111"/>
                  <a:gd name="T18" fmla="+- 0 11778 10444"/>
                  <a:gd name="T19" fmla="*/ 11778 h 9111"/>
                  <a:gd name="T20" fmla="+- 0 18221 10444"/>
                  <a:gd name="T21" fmla="*/ T20 w 9111"/>
                  <a:gd name="T22" fmla="+- 0 11778 10444"/>
                  <a:gd name="T23" fmla="*/ 11778 h 9111"/>
                </a:gdLst>
                <a:ahLst/>
                <a:cxnLst>
                  <a:cxn ang="0">
                    <a:pos x="T1" y="T3"/>
                  </a:cxn>
                  <a:cxn ang="0">
                    <a:pos x="T5" y="T7"/>
                  </a:cxn>
                  <a:cxn ang="0">
                    <a:pos x="T9" y="T11"/>
                  </a:cxn>
                  <a:cxn ang="0">
                    <a:pos x="T13" y="T15"/>
                  </a:cxn>
                  <a:cxn ang="0">
                    <a:pos x="T17" y="T19"/>
                  </a:cxn>
                  <a:cxn ang="0">
                    <a:pos x="T21" y="T23"/>
                  </a:cxn>
                </a:cxnLst>
                <a:rect l="0" t="0" r="r" b="b"/>
                <a:pathLst>
                  <a:path w="9111" h="9111">
                    <a:moveTo>
                      <a:pt x="7777" y="1334"/>
                    </a:moveTo>
                    <a:cubicBezTo>
                      <a:pt x="9556" y="3113"/>
                      <a:pt x="9556" y="5998"/>
                      <a:pt x="7777" y="7777"/>
                    </a:cubicBezTo>
                    <a:cubicBezTo>
                      <a:pt x="5998" y="9556"/>
                      <a:pt x="3113" y="9556"/>
                      <a:pt x="1334" y="7777"/>
                    </a:cubicBezTo>
                    <a:cubicBezTo>
                      <a:pt x="-445" y="5998"/>
                      <a:pt x="-445" y="3113"/>
                      <a:pt x="1334" y="1334"/>
                    </a:cubicBezTo>
                    <a:cubicBezTo>
                      <a:pt x="3113" y="-445"/>
                      <a:pt x="5998" y="-445"/>
                      <a:pt x="7777" y="1334"/>
                    </a:cubicBezTo>
                    <a:close/>
                    <a:moveTo>
                      <a:pt x="7777" y="1334"/>
                    </a:moveTo>
                  </a:path>
                </a:pathLst>
              </a:custGeom>
              <a:solidFill>
                <a:schemeClr val="accent2">
                  <a:lumMod val="20000"/>
                  <a:lumOff val="80000"/>
                </a:schemeClr>
              </a:solidFill>
              <a:ln w="25400">
                <a:solidFill>
                  <a:srgbClr val="000000">
                    <a:alpha val="72180"/>
                  </a:srgbClr>
                </a:solidFill>
                <a:round/>
                <a:headEnd/>
                <a:tailEnd/>
              </a:ln>
              <a:effectLst>
                <a:outerShdw blurRad="63500" dist="76199" dir="2700000" algn="ctr" rotWithShape="0">
                  <a:schemeClr val="bg2">
                    <a:alpha val="75000"/>
                  </a:schemeClr>
                </a:outerShdw>
              </a:effec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" name="Freeform 4"/>
              <p:cNvSpPr>
                <a:spLocks/>
              </p:cNvSpPr>
              <p:nvPr/>
            </p:nvSpPr>
            <p:spPr bwMode="auto">
              <a:xfrm>
                <a:off x="4081463" y="2751138"/>
                <a:ext cx="214312" cy="195262"/>
              </a:xfrm>
              <a:custGeom>
                <a:avLst/>
                <a:gdLst>
                  <a:gd name="T0" fmla="+- 0 18221 10444"/>
                  <a:gd name="T1" fmla="*/ T0 w 9111"/>
                  <a:gd name="T2" fmla="+- 0 11778 10444"/>
                  <a:gd name="T3" fmla="*/ 11778 h 9111"/>
                  <a:gd name="T4" fmla="+- 0 18221 10444"/>
                  <a:gd name="T5" fmla="*/ T4 w 9111"/>
                  <a:gd name="T6" fmla="+- 0 18221 10444"/>
                  <a:gd name="T7" fmla="*/ 18221 h 9111"/>
                  <a:gd name="T8" fmla="+- 0 11778 10444"/>
                  <a:gd name="T9" fmla="*/ T8 w 9111"/>
                  <a:gd name="T10" fmla="+- 0 18221 10444"/>
                  <a:gd name="T11" fmla="*/ 18221 h 9111"/>
                  <a:gd name="T12" fmla="+- 0 11778 10444"/>
                  <a:gd name="T13" fmla="*/ T12 w 9111"/>
                  <a:gd name="T14" fmla="+- 0 11778 10444"/>
                  <a:gd name="T15" fmla="*/ 11778 h 9111"/>
                  <a:gd name="T16" fmla="+- 0 18221 10444"/>
                  <a:gd name="T17" fmla="*/ T16 w 9111"/>
                  <a:gd name="T18" fmla="+- 0 11778 10444"/>
                  <a:gd name="T19" fmla="*/ 11778 h 9111"/>
                  <a:gd name="T20" fmla="+- 0 18221 10444"/>
                  <a:gd name="T21" fmla="*/ T20 w 9111"/>
                  <a:gd name="T22" fmla="+- 0 11778 10444"/>
                  <a:gd name="T23" fmla="*/ 11778 h 9111"/>
                </a:gdLst>
                <a:ahLst/>
                <a:cxnLst>
                  <a:cxn ang="0">
                    <a:pos x="T1" y="T3"/>
                  </a:cxn>
                  <a:cxn ang="0">
                    <a:pos x="T5" y="T7"/>
                  </a:cxn>
                  <a:cxn ang="0">
                    <a:pos x="T9" y="T11"/>
                  </a:cxn>
                  <a:cxn ang="0">
                    <a:pos x="T13" y="T15"/>
                  </a:cxn>
                  <a:cxn ang="0">
                    <a:pos x="T17" y="T19"/>
                  </a:cxn>
                  <a:cxn ang="0">
                    <a:pos x="T21" y="T23"/>
                  </a:cxn>
                </a:cxnLst>
                <a:rect l="0" t="0" r="r" b="b"/>
                <a:pathLst>
                  <a:path w="9111" h="9111">
                    <a:moveTo>
                      <a:pt x="7777" y="1334"/>
                    </a:moveTo>
                    <a:cubicBezTo>
                      <a:pt x="9556" y="3113"/>
                      <a:pt x="9556" y="5998"/>
                      <a:pt x="7777" y="7777"/>
                    </a:cubicBezTo>
                    <a:cubicBezTo>
                      <a:pt x="5998" y="9556"/>
                      <a:pt x="3113" y="9556"/>
                      <a:pt x="1334" y="7777"/>
                    </a:cubicBezTo>
                    <a:cubicBezTo>
                      <a:pt x="-445" y="5998"/>
                      <a:pt x="-445" y="3113"/>
                      <a:pt x="1334" y="1334"/>
                    </a:cubicBezTo>
                    <a:cubicBezTo>
                      <a:pt x="3113" y="-445"/>
                      <a:pt x="5998" y="-445"/>
                      <a:pt x="7777" y="1334"/>
                    </a:cubicBezTo>
                    <a:close/>
                    <a:moveTo>
                      <a:pt x="7777" y="1334"/>
                    </a:moveTo>
                  </a:path>
                </a:pathLst>
              </a:custGeom>
              <a:gradFill rotWithShape="0">
                <a:gsLst>
                  <a:gs pos="0">
                    <a:srgbClr val="00FF80"/>
                  </a:gs>
                  <a:gs pos="100000">
                    <a:srgbClr val="B3B3B3"/>
                  </a:gs>
                </a:gsLst>
                <a:lin ang="20580000" scaled="1"/>
              </a:gradFill>
              <a:ln w="9525">
                <a:solidFill>
                  <a:srgbClr val="000000"/>
                </a:solidFill>
                <a:prstDash val="sysDot"/>
                <a:round/>
                <a:headEnd/>
                <a:tailEnd/>
              </a:ln>
              <a:effectLst>
                <a:outerShdw blurRad="63500" dist="76199" dir="2700000" algn="ctr" rotWithShape="0">
                  <a:schemeClr val="bg2">
                    <a:alpha val="75000"/>
                  </a:schemeClr>
                </a:outerShdw>
              </a:effec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" name="Freeform 6"/>
              <p:cNvSpPr>
                <a:spLocks/>
              </p:cNvSpPr>
              <p:nvPr/>
            </p:nvSpPr>
            <p:spPr bwMode="auto">
              <a:xfrm>
                <a:off x="4143375" y="4572000"/>
                <a:ext cx="3429000" cy="1009650"/>
              </a:xfrm>
              <a:custGeom>
                <a:avLst/>
                <a:gdLst>
                  <a:gd name="T0" fmla="+- 0 18221 10444"/>
                  <a:gd name="T1" fmla="*/ T0 w 9111"/>
                  <a:gd name="T2" fmla="+- 0 11778 10444"/>
                  <a:gd name="T3" fmla="*/ 11778 h 9111"/>
                  <a:gd name="T4" fmla="+- 0 18221 10444"/>
                  <a:gd name="T5" fmla="*/ T4 w 9111"/>
                  <a:gd name="T6" fmla="+- 0 18221 10444"/>
                  <a:gd name="T7" fmla="*/ 18221 h 9111"/>
                  <a:gd name="T8" fmla="+- 0 11778 10444"/>
                  <a:gd name="T9" fmla="*/ T8 w 9111"/>
                  <a:gd name="T10" fmla="+- 0 18221 10444"/>
                  <a:gd name="T11" fmla="*/ 18221 h 9111"/>
                  <a:gd name="T12" fmla="+- 0 11778 10444"/>
                  <a:gd name="T13" fmla="*/ T12 w 9111"/>
                  <a:gd name="T14" fmla="+- 0 11778 10444"/>
                  <a:gd name="T15" fmla="*/ 11778 h 9111"/>
                  <a:gd name="T16" fmla="+- 0 18221 10444"/>
                  <a:gd name="T17" fmla="*/ T16 w 9111"/>
                  <a:gd name="T18" fmla="+- 0 11778 10444"/>
                  <a:gd name="T19" fmla="*/ 11778 h 9111"/>
                  <a:gd name="T20" fmla="+- 0 18221 10444"/>
                  <a:gd name="T21" fmla="*/ T20 w 9111"/>
                  <a:gd name="T22" fmla="+- 0 11778 10444"/>
                  <a:gd name="T23" fmla="*/ 11778 h 9111"/>
                </a:gdLst>
                <a:ahLst/>
                <a:cxnLst>
                  <a:cxn ang="0">
                    <a:pos x="T1" y="T3"/>
                  </a:cxn>
                  <a:cxn ang="0">
                    <a:pos x="T5" y="T7"/>
                  </a:cxn>
                  <a:cxn ang="0">
                    <a:pos x="T9" y="T11"/>
                  </a:cxn>
                  <a:cxn ang="0">
                    <a:pos x="T13" y="T15"/>
                  </a:cxn>
                  <a:cxn ang="0">
                    <a:pos x="T17" y="T19"/>
                  </a:cxn>
                  <a:cxn ang="0">
                    <a:pos x="T21" y="T23"/>
                  </a:cxn>
                </a:cxnLst>
                <a:rect l="0" t="0" r="r" b="b"/>
                <a:pathLst>
                  <a:path w="9111" h="9111">
                    <a:moveTo>
                      <a:pt x="7777" y="1334"/>
                    </a:moveTo>
                    <a:cubicBezTo>
                      <a:pt x="9556" y="3113"/>
                      <a:pt x="9556" y="5998"/>
                      <a:pt x="7777" y="7777"/>
                    </a:cubicBezTo>
                    <a:cubicBezTo>
                      <a:pt x="5998" y="9556"/>
                      <a:pt x="3113" y="9556"/>
                      <a:pt x="1334" y="7777"/>
                    </a:cubicBezTo>
                    <a:cubicBezTo>
                      <a:pt x="-445" y="5998"/>
                      <a:pt x="-445" y="3113"/>
                      <a:pt x="1334" y="1334"/>
                    </a:cubicBezTo>
                    <a:cubicBezTo>
                      <a:pt x="3113" y="-445"/>
                      <a:pt x="5998" y="-445"/>
                      <a:pt x="7777" y="1334"/>
                    </a:cubicBezTo>
                    <a:close/>
                    <a:moveTo>
                      <a:pt x="7777" y="1334"/>
                    </a:moveTo>
                  </a:path>
                </a:pathLst>
              </a:custGeom>
              <a:solidFill>
                <a:srgbClr val="E6E6E6">
                  <a:alpha val="12405"/>
                </a:srgbClr>
              </a:solidFill>
              <a:ln w="25400">
                <a:solidFill>
                  <a:srgbClr val="000000">
                    <a:alpha val="56390"/>
                  </a:srgbClr>
                </a:solidFill>
                <a:prstDash val="solid"/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rgbClr val="000000">
                          <a:alpha val="74998"/>
                        </a:srgb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" name="Freeform 8"/>
              <p:cNvSpPr>
                <a:spLocks/>
              </p:cNvSpPr>
              <p:nvPr/>
            </p:nvSpPr>
            <p:spPr bwMode="auto">
              <a:xfrm>
                <a:off x="4143375" y="5089525"/>
                <a:ext cx="3419475" cy="992188"/>
              </a:xfrm>
              <a:custGeom>
                <a:avLst/>
                <a:gdLst>
                  <a:gd name="T0" fmla="+- 0 18221 10444"/>
                  <a:gd name="T1" fmla="*/ T0 w 9111"/>
                  <a:gd name="T2" fmla="+- 0 11778 10444"/>
                  <a:gd name="T3" fmla="*/ 11778 h 9111"/>
                  <a:gd name="T4" fmla="+- 0 18221 10444"/>
                  <a:gd name="T5" fmla="*/ T4 w 9111"/>
                  <a:gd name="T6" fmla="+- 0 18221 10444"/>
                  <a:gd name="T7" fmla="*/ 18221 h 9111"/>
                  <a:gd name="T8" fmla="+- 0 11778 10444"/>
                  <a:gd name="T9" fmla="*/ T8 w 9111"/>
                  <a:gd name="T10" fmla="+- 0 18221 10444"/>
                  <a:gd name="T11" fmla="*/ 18221 h 9111"/>
                  <a:gd name="T12" fmla="+- 0 11778 10444"/>
                  <a:gd name="T13" fmla="*/ T12 w 9111"/>
                  <a:gd name="T14" fmla="+- 0 11778 10444"/>
                  <a:gd name="T15" fmla="*/ 11778 h 9111"/>
                  <a:gd name="T16" fmla="+- 0 18221 10444"/>
                  <a:gd name="T17" fmla="*/ T16 w 9111"/>
                  <a:gd name="T18" fmla="+- 0 11778 10444"/>
                  <a:gd name="T19" fmla="*/ 11778 h 9111"/>
                  <a:gd name="T20" fmla="+- 0 18221 10444"/>
                  <a:gd name="T21" fmla="*/ T20 w 9111"/>
                  <a:gd name="T22" fmla="+- 0 11778 10444"/>
                  <a:gd name="T23" fmla="*/ 11778 h 9111"/>
                </a:gdLst>
                <a:ahLst/>
                <a:cxnLst>
                  <a:cxn ang="0">
                    <a:pos x="T1" y="T3"/>
                  </a:cxn>
                  <a:cxn ang="0">
                    <a:pos x="T5" y="T7"/>
                  </a:cxn>
                  <a:cxn ang="0">
                    <a:pos x="T9" y="T11"/>
                  </a:cxn>
                  <a:cxn ang="0">
                    <a:pos x="T13" y="T15"/>
                  </a:cxn>
                  <a:cxn ang="0">
                    <a:pos x="T17" y="T19"/>
                  </a:cxn>
                  <a:cxn ang="0">
                    <a:pos x="T21" y="T23"/>
                  </a:cxn>
                </a:cxnLst>
                <a:rect l="0" t="0" r="r" b="b"/>
                <a:pathLst>
                  <a:path w="9111" h="9111">
                    <a:moveTo>
                      <a:pt x="7777" y="1334"/>
                    </a:moveTo>
                    <a:cubicBezTo>
                      <a:pt x="9556" y="3113"/>
                      <a:pt x="9556" y="5998"/>
                      <a:pt x="7777" y="7777"/>
                    </a:cubicBezTo>
                    <a:cubicBezTo>
                      <a:pt x="5998" y="9556"/>
                      <a:pt x="3113" y="9556"/>
                      <a:pt x="1334" y="7777"/>
                    </a:cubicBezTo>
                    <a:cubicBezTo>
                      <a:pt x="-445" y="5998"/>
                      <a:pt x="-445" y="3113"/>
                      <a:pt x="1334" y="1334"/>
                    </a:cubicBezTo>
                    <a:cubicBezTo>
                      <a:pt x="3113" y="-445"/>
                      <a:pt x="5998" y="-445"/>
                      <a:pt x="7777" y="1334"/>
                    </a:cubicBezTo>
                    <a:close/>
                    <a:moveTo>
                      <a:pt x="7777" y="1334"/>
                    </a:moveTo>
                  </a:path>
                </a:pathLst>
              </a:custGeom>
              <a:gradFill rotWithShape="0">
                <a:gsLst>
                  <a:gs pos="0">
                    <a:srgbClr val="FF6ECF">
                      <a:alpha val="50375"/>
                    </a:srgbClr>
                  </a:gs>
                  <a:gs pos="100000">
                    <a:srgbClr val="FF8000">
                      <a:alpha val="50375"/>
                    </a:srgbClr>
                  </a:gs>
                </a:gsLst>
                <a:lin ang="16200000" scaled="1"/>
              </a:gradFill>
              <a:ln w="25400">
                <a:solidFill>
                  <a:srgbClr val="000000">
                    <a:alpha val="50375"/>
                  </a:srgbClr>
                </a:solidFill>
                <a:prstDash val="solid"/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rgbClr val="000000">
                          <a:alpha val="74998"/>
                        </a:srgb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" name="Line 9"/>
              <p:cNvSpPr>
                <a:spLocks noChangeShapeType="1"/>
              </p:cNvSpPr>
              <p:nvPr/>
            </p:nvSpPr>
            <p:spPr bwMode="auto">
              <a:xfrm>
                <a:off x="4143375" y="5054600"/>
                <a:ext cx="0" cy="544513"/>
              </a:xfrm>
              <a:prstGeom prst="line">
                <a:avLst/>
              </a:prstGeom>
              <a:noFill/>
              <a:ln w="25400">
                <a:solidFill>
                  <a:srgbClr val="181818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rgbClr val="000000">
                          <a:alpha val="74998"/>
                        </a:srgb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" name="Line 10"/>
              <p:cNvSpPr>
                <a:spLocks noChangeShapeType="1"/>
              </p:cNvSpPr>
              <p:nvPr/>
            </p:nvSpPr>
            <p:spPr bwMode="auto">
              <a:xfrm>
                <a:off x="7572375" y="5081588"/>
                <a:ext cx="0" cy="508000"/>
              </a:xfrm>
              <a:prstGeom prst="line">
                <a:avLst/>
              </a:prstGeom>
              <a:noFill/>
              <a:ln w="25400">
                <a:solidFill>
                  <a:srgbClr val="181818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rgbClr val="000000">
                          <a:alpha val="74998"/>
                        </a:srgb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" name="Text Box 11"/>
              <p:cNvSpPr txBox="1">
                <a:spLocks noChangeArrowheads="1"/>
              </p:cNvSpPr>
              <p:nvPr/>
            </p:nvSpPr>
            <p:spPr bwMode="auto">
              <a:xfrm>
                <a:off x="1657711" y="2643188"/>
                <a:ext cx="1556616" cy="36933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1pPr>
                <a:lvl2pPr marL="320675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642938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963613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1285875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17430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2002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26574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1146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en-US" b="1" baseline="0" dirty="0">
                    <a:latin typeface="Arial" charset="0"/>
                  </a:rPr>
                  <a:t>Blastocyst</a:t>
                </a:r>
              </a:p>
            </p:txBody>
          </p:sp>
          <p:sp>
            <p:nvSpPr>
              <p:cNvPr id="15" name="Text Box 12"/>
              <p:cNvSpPr txBox="1">
                <a:spLocks noChangeArrowheads="1"/>
              </p:cNvSpPr>
              <p:nvPr/>
            </p:nvSpPr>
            <p:spPr bwMode="auto">
              <a:xfrm>
                <a:off x="1278505" y="3376613"/>
                <a:ext cx="2334088" cy="4948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1pPr>
                <a:lvl2pPr marL="320675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642938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963613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1285875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17430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2002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26574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1146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en-US" b="1" baseline="0" dirty="0" err="1">
                    <a:latin typeface="Arial" charset="0"/>
                  </a:rPr>
                  <a:t>Matrigel</a:t>
                </a:r>
                <a:r>
                  <a:rPr lang="en-US" b="1" baseline="0" dirty="0">
                    <a:latin typeface="Arial" charset="0"/>
                  </a:rPr>
                  <a:t> </a:t>
                </a:r>
                <a:r>
                  <a:rPr lang="en-US" b="1" baseline="0" dirty="0" smtClean="0">
                    <a:latin typeface="Arial" charset="0"/>
                  </a:rPr>
                  <a:t>Raft:</a:t>
                </a:r>
              </a:p>
              <a:p>
                <a:pPr algn="ctr" eaLnBrk="1" hangingPunct="1"/>
                <a:r>
                  <a:rPr lang="en-US" sz="1600" b="1" dirty="0" smtClean="0">
                    <a:latin typeface="Arial" charset="0"/>
                  </a:rPr>
                  <a:t>Coverslip coated in </a:t>
                </a:r>
                <a:r>
                  <a:rPr lang="en-US" sz="1600" b="1" dirty="0" err="1" smtClean="0">
                    <a:latin typeface="Arial" charset="0"/>
                  </a:rPr>
                  <a:t>Matrigel</a:t>
                </a:r>
                <a:endParaRPr lang="en-US" sz="1600" b="1" baseline="0" dirty="0">
                  <a:latin typeface="Arial" charset="0"/>
                </a:endParaRPr>
              </a:p>
            </p:txBody>
          </p:sp>
          <p:sp>
            <p:nvSpPr>
              <p:cNvPr id="16" name="Text Box 13"/>
              <p:cNvSpPr txBox="1">
                <a:spLocks noChangeArrowheads="1"/>
              </p:cNvSpPr>
              <p:nvPr/>
            </p:nvSpPr>
            <p:spPr bwMode="auto">
              <a:xfrm>
                <a:off x="1036638" y="4805363"/>
                <a:ext cx="2794000" cy="73866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1pPr>
                <a:lvl2pPr marL="320675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642938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963613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1285875" defTabSz="642938"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17430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2002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26574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114675" defTabSz="642938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749300" algn="l"/>
                  </a:tabLst>
                  <a:defRPr sz="24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en-US" b="1" baseline="0" dirty="0">
                    <a:latin typeface="Arial" charset="0"/>
                  </a:rPr>
                  <a:t>Feeder cell plated 35 mm 6-well dish</a:t>
                </a:r>
              </a:p>
            </p:txBody>
          </p:sp>
          <p:sp>
            <p:nvSpPr>
              <p:cNvPr id="17" name="Freeform 15"/>
              <p:cNvSpPr>
                <a:spLocks/>
              </p:cNvSpPr>
              <p:nvPr/>
            </p:nvSpPr>
            <p:spPr bwMode="auto">
              <a:xfrm>
                <a:off x="4143375" y="5000625"/>
                <a:ext cx="3419475" cy="990600"/>
              </a:xfrm>
              <a:custGeom>
                <a:avLst/>
                <a:gdLst>
                  <a:gd name="T0" fmla="+- 0 18221 10444"/>
                  <a:gd name="T1" fmla="*/ T0 w 9111"/>
                  <a:gd name="T2" fmla="+- 0 11778 10444"/>
                  <a:gd name="T3" fmla="*/ 11778 h 9111"/>
                  <a:gd name="T4" fmla="+- 0 18221 10444"/>
                  <a:gd name="T5" fmla="*/ T4 w 9111"/>
                  <a:gd name="T6" fmla="+- 0 18221 10444"/>
                  <a:gd name="T7" fmla="*/ 18221 h 9111"/>
                  <a:gd name="T8" fmla="+- 0 11778 10444"/>
                  <a:gd name="T9" fmla="*/ T8 w 9111"/>
                  <a:gd name="T10" fmla="+- 0 18221 10444"/>
                  <a:gd name="T11" fmla="*/ 18221 h 9111"/>
                  <a:gd name="T12" fmla="+- 0 11778 10444"/>
                  <a:gd name="T13" fmla="*/ T12 w 9111"/>
                  <a:gd name="T14" fmla="+- 0 11778 10444"/>
                  <a:gd name="T15" fmla="*/ 11778 h 9111"/>
                  <a:gd name="T16" fmla="+- 0 18221 10444"/>
                  <a:gd name="T17" fmla="*/ T16 w 9111"/>
                  <a:gd name="T18" fmla="+- 0 11778 10444"/>
                  <a:gd name="T19" fmla="*/ 11778 h 9111"/>
                  <a:gd name="T20" fmla="+- 0 18221 10444"/>
                  <a:gd name="T21" fmla="*/ T20 w 9111"/>
                  <a:gd name="T22" fmla="+- 0 11778 10444"/>
                  <a:gd name="T23" fmla="*/ 11778 h 9111"/>
                </a:gdLst>
                <a:ahLst/>
                <a:cxnLst>
                  <a:cxn ang="0">
                    <a:pos x="T1" y="T3"/>
                  </a:cxn>
                  <a:cxn ang="0">
                    <a:pos x="T5" y="T7"/>
                  </a:cxn>
                  <a:cxn ang="0">
                    <a:pos x="T9" y="T11"/>
                  </a:cxn>
                  <a:cxn ang="0">
                    <a:pos x="T13" y="T15"/>
                  </a:cxn>
                  <a:cxn ang="0">
                    <a:pos x="T17" y="T19"/>
                  </a:cxn>
                  <a:cxn ang="0">
                    <a:pos x="T21" y="T23"/>
                  </a:cxn>
                </a:cxnLst>
                <a:rect l="0" t="0" r="r" b="b"/>
                <a:pathLst>
                  <a:path w="9111" h="9111">
                    <a:moveTo>
                      <a:pt x="7777" y="1334"/>
                    </a:moveTo>
                    <a:cubicBezTo>
                      <a:pt x="9556" y="3113"/>
                      <a:pt x="9556" y="5998"/>
                      <a:pt x="7777" y="7777"/>
                    </a:cubicBezTo>
                    <a:cubicBezTo>
                      <a:pt x="5998" y="9556"/>
                      <a:pt x="3113" y="9556"/>
                      <a:pt x="1334" y="7777"/>
                    </a:cubicBezTo>
                    <a:cubicBezTo>
                      <a:pt x="-445" y="5998"/>
                      <a:pt x="-445" y="3113"/>
                      <a:pt x="1334" y="1334"/>
                    </a:cubicBezTo>
                    <a:cubicBezTo>
                      <a:pt x="3113" y="-445"/>
                      <a:pt x="5998" y="-445"/>
                      <a:pt x="7777" y="1334"/>
                    </a:cubicBezTo>
                    <a:close/>
                    <a:moveTo>
                      <a:pt x="7777" y="1334"/>
                    </a:moveTo>
                  </a:path>
                </a:pathLst>
              </a:custGeom>
              <a:gradFill rotWithShape="0">
                <a:gsLst>
                  <a:gs pos="0">
                    <a:srgbClr val="FF6ECF">
                      <a:alpha val="50375"/>
                    </a:srgbClr>
                  </a:gs>
                  <a:gs pos="100000">
                    <a:srgbClr val="FF8000">
                      <a:alpha val="50375"/>
                    </a:srgbClr>
                  </a:gs>
                </a:gsLst>
                <a:lin ang="16200000" scaled="1"/>
              </a:gra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25400">
                    <a:solidFill>
                      <a:srgbClr val="000000">
                        <a:alpha val="50375"/>
                      </a:srgbClr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rgbClr val="000000">
                          <a:alpha val="74998"/>
                        </a:srgb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cxnSp>
          <p:nvCxnSpPr>
            <p:cNvPr id="19" name="Straight Arrow Connector 18"/>
            <p:cNvCxnSpPr/>
            <p:nvPr/>
          </p:nvCxnSpPr>
          <p:spPr>
            <a:xfrm>
              <a:off x="4402667" y="2946400"/>
              <a:ext cx="931333" cy="430213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>
              <a:off x="5644444" y="4014080"/>
              <a:ext cx="56444" cy="79780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169333" y="155222"/>
            <a:ext cx="254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Times New Roman"/>
                <a:cs typeface="Times New Roman"/>
              </a:rPr>
              <a:t>Additional File 1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650856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8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a</dc:creator>
  <cp:lastModifiedBy>Microsoft Office User</cp:lastModifiedBy>
  <cp:revision>3</cp:revision>
  <dcterms:created xsi:type="dcterms:W3CDTF">2016-11-10T14:36:59Z</dcterms:created>
  <dcterms:modified xsi:type="dcterms:W3CDTF">2017-12-19T17:29:49Z</dcterms:modified>
</cp:coreProperties>
</file>